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1" autoAdjust="0"/>
    <p:restoredTop sz="94660"/>
  </p:normalViewPr>
  <p:slideViewPr>
    <p:cSldViewPr showGuides="1">
      <p:cViewPr varScale="1">
        <p:scale>
          <a:sx n="65" d="100"/>
          <a:sy n="65" d="100"/>
        </p:scale>
        <p:origin x="2405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110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6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342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186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20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5113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380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6795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9877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6961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9665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1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6F244793-911F-4927-95CF-14B61B9FAF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-4698998" y="58517"/>
            <a:ext cx="246286" cy="4925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21920" tIns="60961" rIns="121920" bIns="60961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2401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37884A3-8174-4848-BAE3-0E520027FBF6}"/>
              </a:ext>
            </a:extLst>
          </p:cNvPr>
          <p:cNvSpPr txBox="1"/>
          <p:nvPr/>
        </p:nvSpPr>
        <p:spPr>
          <a:xfrm>
            <a:off x="260648" y="6471691"/>
            <a:ext cx="6336704" cy="25648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3120"/>
              </a:spcBef>
              <a:spcAft>
                <a:spcPts val="780"/>
              </a:spcAft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. Transcript level of JA-responsive genes on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JA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eatment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cript level of the anthocyanin biosynthetic gene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L3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WT,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ar1-1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eedlings grown on MS media supplemented with 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0, 10, and 20 </a:t>
            </a:r>
            <a:r>
              <a:rPr lang="en-US" altLang="zh-CN" sz="14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JA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or 8 days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Data are mean</a:t>
            </a:r>
            <a:r>
              <a:rPr lang="zh-CN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±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D (n=3 samples, each sample contains 20 seedlings)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)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cript level of the JA biosynthetic genes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OS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and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PR3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and defensive genes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DF1.2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and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SP1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in WT,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ar1-1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eedlings grown on MS media supplemented with 0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Mock) or 20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JA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 8 days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Data are mean</a:t>
            </a:r>
            <a:r>
              <a:rPr lang="zh-CN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±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D (n=2~3 samples, each sample contains 20 seedlings). 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CTIN8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as used as the internal control. Asterisks indicate significant difference from WT (Student’s t-test, * p &lt; 0.05, ** p &lt; 0.01, *** p &lt; 0.001)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55C12E8-F316-48F6-AAB9-A3CFA535FC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736" y="179512"/>
            <a:ext cx="4721352" cy="6045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344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175</Words>
  <Application>Microsoft Office PowerPoint</Application>
  <PresentationFormat>信纸(8.5x11 英寸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gnita</dc:creator>
  <cp:lastModifiedBy>Yuwen Li</cp:lastModifiedBy>
  <cp:revision>13</cp:revision>
  <dcterms:created xsi:type="dcterms:W3CDTF">2020-11-11T06:41:23Z</dcterms:created>
  <dcterms:modified xsi:type="dcterms:W3CDTF">2021-08-06T04:41:57Z</dcterms:modified>
</cp:coreProperties>
</file>